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480175" cy="5040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04" autoAdjust="0"/>
    <p:restoredTop sz="94660"/>
  </p:normalViewPr>
  <p:slideViewPr>
    <p:cSldViewPr snapToGrid="0">
      <p:cViewPr varScale="1">
        <p:scale>
          <a:sx n="153" d="100"/>
          <a:sy n="153" d="100"/>
        </p:scale>
        <p:origin x="2250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eahome3\stfsci1\nmv06xuu\data\Documents\Research\Papers\Chondrosarcoma%20tRNA\Northern%20blot%20quan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84F-47CA-8487-FFAED3AD3DCC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84F-47CA-8487-FFAED3AD3DCC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84F-47CA-8487-FFAED3AD3DCC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84F-47CA-8487-FFAED3AD3DCC}"/>
              </c:ext>
            </c:extLst>
          </c:dPt>
          <c:cat>
            <c:strRef>
              <c:f>Sheet1!$A$26:$A$29</c:f>
              <c:strCache>
                <c:ptCount val="4"/>
                <c:pt idx="0">
                  <c:v>Control</c:v>
                </c:pt>
                <c:pt idx="1">
                  <c:v>Low</c:v>
                </c:pt>
                <c:pt idx="2">
                  <c:v>Intermediate</c:v>
                </c:pt>
                <c:pt idx="3">
                  <c:v>High</c:v>
                </c:pt>
              </c:strCache>
            </c:strRef>
          </c:cat>
          <c:val>
            <c:numRef>
              <c:f>Sheet1!$B$26:$B$29</c:f>
              <c:numCache>
                <c:formatCode>General</c:formatCode>
                <c:ptCount val="4"/>
                <c:pt idx="0">
                  <c:v>54</c:v>
                </c:pt>
                <c:pt idx="1">
                  <c:v>85</c:v>
                </c:pt>
                <c:pt idx="2">
                  <c:v>95</c:v>
                </c:pt>
                <c:pt idx="3">
                  <c:v>2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84F-47CA-8487-FFAED3AD3DCC}"/>
            </c:ext>
          </c:extLst>
        </c:ser>
        <c:ser>
          <c:idx val="1"/>
          <c:order val="1"/>
          <c:spPr>
            <a:pattFill prst="dkDnDiag">
              <a:fgClr>
                <a:schemeClr val="bg1">
                  <a:lumMod val="85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78F1-4614-835C-5533DE85DDF7}"/>
              </c:ext>
            </c:extLst>
          </c:dPt>
          <c:cat>
            <c:strRef>
              <c:f>Sheet1!$A$26:$A$29</c:f>
              <c:strCache>
                <c:ptCount val="4"/>
                <c:pt idx="0">
                  <c:v>Control</c:v>
                </c:pt>
                <c:pt idx="1">
                  <c:v>Low</c:v>
                </c:pt>
                <c:pt idx="2">
                  <c:v>Intermediate</c:v>
                </c:pt>
                <c:pt idx="3">
                  <c:v>High</c:v>
                </c:pt>
              </c:strCache>
            </c:strRef>
          </c:cat>
          <c:val>
            <c:numRef>
              <c:f>Sheet1!$C$26:$C$29</c:f>
              <c:numCache>
                <c:formatCode>General</c:formatCode>
                <c:ptCount val="4"/>
                <c:pt idx="0">
                  <c:v>210</c:v>
                </c:pt>
                <c:pt idx="1">
                  <c:v>186</c:v>
                </c:pt>
                <c:pt idx="2">
                  <c:v>185</c:v>
                </c:pt>
                <c:pt idx="3">
                  <c:v>1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484F-47CA-8487-FFAED3AD3D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2730400"/>
        <c:axId val="472731056"/>
      </c:barChart>
      <c:catAx>
        <c:axId val="47273040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472731056"/>
        <c:crosses val="autoZero"/>
        <c:auto val="1"/>
        <c:lblAlgn val="ctr"/>
        <c:lblOffset val="100"/>
        <c:noMultiLvlLbl val="0"/>
      </c:catAx>
      <c:valAx>
        <c:axId val="4727310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727304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824885"/>
            <a:ext cx="5508149" cy="1754776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2647331"/>
            <a:ext cx="4860131" cy="1216909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52697-73D1-462A-86AE-A0E90A1392CB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7BDB4-35CF-406B-A2D0-B2093CD80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4181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52697-73D1-462A-86AE-A0E90A1392CB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7BDB4-35CF-406B-A2D0-B2093CD80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3261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268350"/>
            <a:ext cx="1397288" cy="427143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268350"/>
            <a:ext cx="4110861" cy="427143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52697-73D1-462A-86AE-A0E90A1392CB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7BDB4-35CF-406B-A2D0-B2093CD80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4575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52697-73D1-462A-86AE-A0E90A1392CB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7BDB4-35CF-406B-A2D0-B2093CD80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8064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256579"/>
            <a:ext cx="5589151" cy="2096630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3373044"/>
            <a:ext cx="5589151" cy="110256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52697-73D1-462A-86AE-A0E90A1392CB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7BDB4-35CF-406B-A2D0-B2093CD80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2034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341750"/>
            <a:ext cx="2754074" cy="319803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341750"/>
            <a:ext cx="2754074" cy="319803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52697-73D1-462A-86AE-A0E90A1392CB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7BDB4-35CF-406B-A2D0-B2093CD80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1182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268351"/>
            <a:ext cx="5589151" cy="97422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235577"/>
            <a:ext cx="2741417" cy="60553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1841114"/>
            <a:ext cx="2741417" cy="270800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235577"/>
            <a:ext cx="2754918" cy="60553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1841114"/>
            <a:ext cx="2754918" cy="270800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52697-73D1-462A-86AE-A0E90A1392CB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7BDB4-35CF-406B-A2D0-B2093CD80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3342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52697-73D1-462A-86AE-A0E90A1392CB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7BDB4-35CF-406B-A2D0-B2093CD80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6734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52697-73D1-462A-86AE-A0E90A1392CB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7BDB4-35CF-406B-A2D0-B2093CD80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8021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36021"/>
            <a:ext cx="2090025" cy="1176073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725713"/>
            <a:ext cx="3280589" cy="3581889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512094"/>
            <a:ext cx="2090025" cy="2801341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52697-73D1-462A-86AE-A0E90A1392CB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7BDB4-35CF-406B-A2D0-B2093CD80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1546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36021"/>
            <a:ext cx="2090025" cy="1176073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725713"/>
            <a:ext cx="3280589" cy="3581889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512094"/>
            <a:ext cx="2090025" cy="2801341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52697-73D1-462A-86AE-A0E90A1392CB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7BDB4-35CF-406B-A2D0-B2093CD80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8807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268351"/>
            <a:ext cx="5589151" cy="9742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341750"/>
            <a:ext cx="5589151" cy="31980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4671625"/>
            <a:ext cx="1458039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352697-73D1-462A-86AE-A0E90A1392CB}" type="datetimeFigureOut">
              <a:rPr lang="en-GB" smtClean="0"/>
              <a:t>25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4671625"/>
            <a:ext cx="2187059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4671625"/>
            <a:ext cx="1458039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7BDB4-35CF-406B-A2D0-B2093CD80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3886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chart" Target="../charts/chart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pn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-658028" y="801021"/>
            <a:ext cx="1714912" cy="3936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57" dirty="0">
                <a:latin typeface="Arial" panose="020B0604020202020204" pitchFamily="34" charset="0"/>
                <a:cs typeface="Arial" panose="020B0604020202020204" pitchFamily="34" charset="0"/>
              </a:rPr>
              <a:t>miR-140 </a:t>
            </a:r>
            <a:r>
              <a:rPr lang="en-GB" sz="1001" dirty="0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r>
              <a:rPr lang="en-GB" sz="957" dirty="0">
                <a:latin typeface="Arial" panose="020B0604020202020204" pitchFamily="34" charset="0"/>
                <a:cs typeface="Arial" panose="020B0604020202020204" pitchFamily="34" charset="0"/>
              </a:rPr>
              <a:t> &amp; </a:t>
            </a:r>
            <a:r>
              <a:rPr lang="en-GB" sz="957" i="1" dirty="0">
                <a:latin typeface="Arial" panose="020B0604020202020204" pitchFamily="34" charset="0"/>
                <a:cs typeface="Arial" panose="020B0604020202020204" pitchFamily="34" charset="0"/>
              </a:rPr>
              <a:t>RNU6-1</a:t>
            </a:r>
            <a:r>
              <a:rPr lang="en-GB" sz="957" dirty="0">
                <a:latin typeface="Arial" panose="020B0604020202020204" pitchFamily="34" charset="0"/>
                <a:cs typeface="Arial" panose="020B0604020202020204" pitchFamily="34" charset="0"/>
              </a:rPr>
              <a:t> equal loading</a:t>
            </a:r>
            <a:endParaRPr lang="en-GB" sz="95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543024" y="1728558"/>
            <a:ext cx="694773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00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772669" y="1801366"/>
            <a:ext cx="853686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1" dirty="0">
                <a:latin typeface="Arial" panose="020B0604020202020204" pitchFamily="34" charset="0"/>
                <a:cs typeface="Arial" panose="020B0604020202020204" pitchFamily="34" charset="0"/>
              </a:rPr>
              <a:t>Low-grade</a:t>
            </a:r>
            <a:endParaRPr lang="en-GB" sz="100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1063805" y="1813470"/>
            <a:ext cx="857255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1" dirty="0">
                <a:latin typeface="Arial" panose="020B0604020202020204" pitchFamily="34" charset="0"/>
                <a:cs typeface="Arial" panose="020B0604020202020204" pitchFamily="34" charset="0"/>
              </a:rPr>
              <a:t>Inter-grade</a:t>
            </a:r>
            <a:endParaRPr lang="en-GB" sz="100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376235" y="1808437"/>
            <a:ext cx="864131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1" dirty="0">
                <a:latin typeface="Arial" panose="020B0604020202020204" pitchFamily="34" charset="0"/>
                <a:cs typeface="Arial" panose="020B0604020202020204" pitchFamily="34" charset="0"/>
              </a:rPr>
              <a:t>High-grade</a:t>
            </a:r>
            <a:endParaRPr lang="en-GB" sz="100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8905508"/>
              </p:ext>
            </p:extLst>
          </p:nvPr>
        </p:nvGraphicFramePr>
        <p:xfrm>
          <a:off x="335845" y="185090"/>
          <a:ext cx="1757594" cy="14580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0" y="1884"/>
            <a:ext cx="3949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938720" y="1886"/>
            <a:ext cx="319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8075" y="282033"/>
            <a:ext cx="993482" cy="755102"/>
          </a:xfrm>
          <a:prstGeom prst="rect">
            <a:avLst/>
          </a:prstGeom>
        </p:spPr>
      </p:pic>
      <p:sp>
        <p:nvSpPr>
          <p:cNvPr id="14" name="TextBox 4"/>
          <p:cNvSpPr txBox="1"/>
          <p:nvPr/>
        </p:nvSpPr>
        <p:spPr>
          <a:xfrm>
            <a:off x="4325646" y="286801"/>
            <a:ext cx="962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F-</a:t>
            </a:r>
            <a:r>
              <a:rPr lang="en-GB" sz="8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</a:t>
            </a:r>
            <a:r>
              <a:rPr lang="en-GB" sz="800" baseline="30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T</a:t>
            </a:r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mic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4971" y="278883"/>
            <a:ext cx="1007373" cy="758254"/>
          </a:xfrm>
          <a:prstGeom prst="rect">
            <a:avLst/>
          </a:prstGeom>
        </p:spPr>
      </p:pic>
      <p:sp>
        <p:nvSpPr>
          <p:cNvPr id="16" name="TextBox 4"/>
          <p:cNvSpPr txBox="1"/>
          <p:nvPr/>
        </p:nvSpPr>
        <p:spPr>
          <a:xfrm>
            <a:off x="5359131" y="284121"/>
            <a:ext cx="10570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F-</a:t>
            </a:r>
            <a:r>
              <a:rPr lang="en-GB" sz="8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</a:t>
            </a:r>
            <a:r>
              <a:rPr lang="en-GB" sz="800" baseline="30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T</a:t>
            </a:r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hibitor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4539" y="1058475"/>
            <a:ext cx="1011149" cy="7525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1320" y="1053630"/>
            <a:ext cx="993692" cy="753625"/>
          </a:xfrm>
          <a:prstGeom prst="rect">
            <a:avLst/>
          </a:prstGeom>
        </p:spPr>
      </p:pic>
      <p:sp>
        <p:nvSpPr>
          <p:cNvPr id="19" name="TextBox 4"/>
          <p:cNvSpPr txBox="1"/>
          <p:nvPr/>
        </p:nvSpPr>
        <p:spPr>
          <a:xfrm>
            <a:off x="2248245" y="1053711"/>
            <a:ext cx="9842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F-</a:t>
            </a:r>
            <a:r>
              <a:rPr lang="en-GB" sz="8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n</a:t>
            </a:r>
            <a:r>
              <a:rPr lang="en-GB" sz="800" baseline="30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TT</a:t>
            </a:r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mic</a:t>
            </a:r>
          </a:p>
        </p:txBody>
      </p:sp>
      <p:sp>
        <p:nvSpPr>
          <p:cNvPr id="20" name="TextBox 4"/>
          <p:cNvSpPr txBox="1"/>
          <p:nvPr/>
        </p:nvSpPr>
        <p:spPr>
          <a:xfrm>
            <a:off x="3283210" y="1064300"/>
            <a:ext cx="10954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F-</a:t>
            </a:r>
            <a:r>
              <a:rPr lang="en-GB" sz="8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n</a:t>
            </a:r>
            <a:r>
              <a:rPr lang="en-GB" sz="800" baseline="30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TT</a:t>
            </a:r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hibitor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8075" y="1063390"/>
            <a:ext cx="993482" cy="747585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1295" y="1067826"/>
            <a:ext cx="1011044" cy="743145"/>
          </a:xfrm>
          <a:prstGeom prst="rect">
            <a:avLst/>
          </a:prstGeom>
        </p:spPr>
      </p:pic>
      <p:sp>
        <p:nvSpPr>
          <p:cNvPr id="23" name="TextBox 4"/>
          <p:cNvSpPr txBox="1"/>
          <p:nvPr/>
        </p:nvSpPr>
        <p:spPr>
          <a:xfrm>
            <a:off x="4323678" y="1067827"/>
            <a:ext cx="9368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140 mimic</a:t>
            </a:r>
          </a:p>
        </p:txBody>
      </p:sp>
      <p:sp>
        <p:nvSpPr>
          <p:cNvPr id="24" name="TextBox 4"/>
          <p:cNvSpPr txBox="1"/>
          <p:nvPr/>
        </p:nvSpPr>
        <p:spPr>
          <a:xfrm>
            <a:off x="5359418" y="1072719"/>
            <a:ext cx="10172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140 inhibitor</a:t>
            </a:r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3280" y="1866952"/>
            <a:ext cx="1014490" cy="743145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1345" y="1871848"/>
            <a:ext cx="1017213" cy="738252"/>
          </a:xfrm>
          <a:prstGeom prst="rect">
            <a:avLst/>
          </a:prstGeom>
        </p:spPr>
      </p:pic>
      <p:sp>
        <p:nvSpPr>
          <p:cNvPr id="27" name="TextBox 4"/>
          <p:cNvSpPr txBox="1"/>
          <p:nvPr/>
        </p:nvSpPr>
        <p:spPr>
          <a:xfrm>
            <a:off x="2219547" y="1870305"/>
            <a:ext cx="9748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320a mimic</a:t>
            </a:r>
          </a:p>
        </p:txBody>
      </p:sp>
      <p:sp>
        <p:nvSpPr>
          <p:cNvPr id="28" name="TextBox 4"/>
          <p:cNvSpPr txBox="1"/>
          <p:nvPr/>
        </p:nvSpPr>
        <p:spPr>
          <a:xfrm>
            <a:off x="3265957" y="1870610"/>
            <a:ext cx="10984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320a inhibitor</a:t>
            </a: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8082" y="1860322"/>
            <a:ext cx="994026" cy="749778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5205" y="1864758"/>
            <a:ext cx="1007139" cy="745338"/>
          </a:xfrm>
          <a:prstGeom prst="rect">
            <a:avLst/>
          </a:prstGeom>
        </p:spPr>
      </p:pic>
      <p:sp>
        <p:nvSpPr>
          <p:cNvPr id="31" name="TextBox 4"/>
          <p:cNvSpPr txBox="1"/>
          <p:nvPr/>
        </p:nvSpPr>
        <p:spPr>
          <a:xfrm>
            <a:off x="4323043" y="1867124"/>
            <a:ext cx="9164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486 mimic</a:t>
            </a:r>
          </a:p>
        </p:txBody>
      </p:sp>
      <p:sp>
        <p:nvSpPr>
          <p:cNvPr id="32" name="TextBox 4"/>
          <p:cNvSpPr txBox="1"/>
          <p:nvPr/>
        </p:nvSpPr>
        <p:spPr>
          <a:xfrm>
            <a:off x="5355583" y="1867889"/>
            <a:ext cx="10563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486 inhibitor</a:t>
            </a:r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1179" y="284117"/>
            <a:ext cx="1007372" cy="745392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3366" y="284118"/>
            <a:ext cx="984409" cy="745392"/>
          </a:xfrm>
          <a:prstGeom prst="rect">
            <a:avLst/>
          </a:prstGeom>
        </p:spPr>
      </p:pic>
      <p:sp>
        <p:nvSpPr>
          <p:cNvPr id="35" name="TextBox 4"/>
          <p:cNvSpPr txBox="1"/>
          <p:nvPr/>
        </p:nvSpPr>
        <p:spPr>
          <a:xfrm>
            <a:off x="2247995" y="286822"/>
            <a:ext cx="9042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mic control</a:t>
            </a:r>
          </a:p>
        </p:txBody>
      </p:sp>
      <p:sp>
        <p:nvSpPr>
          <p:cNvPr id="36" name="TextBox 4"/>
          <p:cNvSpPr txBox="1"/>
          <p:nvPr/>
        </p:nvSpPr>
        <p:spPr>
          <a:xfrm>
            <a:off x="3277863" y="285756"/>
            <a:ext cx="9999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hibitor control</a:t>
            </a: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213280" y="2669795"/>
            <a:ext cx="1014490" cy="682954"/>
          </a:xfrm>
          <a:prstGeom prst="rect">
            <a:avLst/>
          </a:prstGeom>
        </p:spPr>
      </p:pic>
      <p:sp>
        <p:nvSpPr>
          <p:cNvPr id="38" name="TextBox 4"/>
          <p:cNvSpPr txBox="1"/>
          <p:nvPr/>
        </p:nvSpPr>
        <p:spPr>
          <a:xfrm>
            <a:off x="2213282" y="2669796"/>
            <a:ext cx="7770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treatment</a:t>
            </a: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261343" y="2667016"/>
            <a:ext cx="1015726" cy="685737"/>
          </a:xfrm>
          <a:prstGeom prst="rect">
            <a:avLst/>
          </a:prstGeom>
        </p:spPr>
      </p:pic>
      <p:sp>
        <p:nvSpPr>
          <p:cNvPr id="40" name="TextBox 4"/>
          <p:cNvSpPr txBox="1"/>
          <p:nvPr/>
        </p:nvSpPr>
        <p:spPr>
          <a:xfrm>
            <a:off x="3266102" y="2666420"/>
            <a:ext cx="10463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02238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0447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6712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0895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11187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13425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15663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7900" algn="l" defTabSz="804475" rtl="0" eaLnBrk="1" latinLnBrk="0" hangingPunct="1">
              <a:defRPr sz="15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F-Gly</a:t>
            </a:r>
            <a:r>
              <a:rPr lang="en-GB" sz="800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C</a:t>
            </a:r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mic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D198829-EBC5-4286-85FA-0285A8FE5C1C}"/>
              </a:ext>
            </a:extLst>
          </p:cNvPr>
          <p:cNvSpPr txBox="1"/>
          <p:nvPr/>
        </p:nvSpPr>
        <p:spPr>
          <a:xfrm>
            <a:off x="68837" y="3409666"/>
            <a:ext cx="6418046" cy="11486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. Fig. 1.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xel quantification of miR-140 expression (grey columns) with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NU6-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normalisation (grey dashed lines) using ImageJ.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.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RNA gain- and loss-of-function experiments. The DAPI only panels (bottom) were used for nuclei number/size analysis using ImageJ. 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6">
            <a:extLst>
              <a:ext uri="{FF2B5EF4-FFF2-40B4-BE49-F238E27FC236}">
                <a16:creationId xmlns:a16="http://schemas.microsoft.com/office/drawing/2014/main" id="{01A6C36C-DDDE-2352-B931-3CC8303AEF67}"/>
              </a:ext>
            </a:extLst>
          </p:cNvPr>
          <p:cNvSpPr txBox="1"/>
          <p:nvPr/>
        </p:nvSpPr>
        <p:spPr>
          <a:xfrm>
            <a:off x="111083" y="0"/>
            <a:ext cx="1760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72429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</TotalTime>
  <Words>97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East Angl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ll Green (MED - Staff)</dc:creator>
  <cp:lastModifiedBy>Darrell Green (MED - Staff)</cp:lastModifiedBy>
  <cp:revision>19</cp:revision>
  <dcterms:created xsi:type="dcterms:W3CDTF">2021-06-01T14:27:49Z</dcterms:created>
  <dcterms:modified xsi:type="dcterms:W3CDTF">2023-01-25T11:10:53Z</dcterms:modified>
</cp:coreProperties>
</file>